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2A2EB-5328-4B07-8E61-F0497047C5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33798-B878-4C2C-9733-F76F691D27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827FD-AF11-4D48-AE7C-D322C21CE8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A2384-11F7-4AB9-A7C4-F905171B67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5E3B3-21BA-4A98-B948-11CB98CD08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E514C-CF00-45C6-9A98-72C5D44A5F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9F56F-6A49-4B72-B397-2EECE6A45C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C574D-7D35-45A6-9EF6-0F326394DF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3F364-3F3E-48CB-B27D-25DFFEADE1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A5B14-0C6F-436D-9A2B-A9627F0984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7582C-E458-4E16-86DE-11914B4C7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218BF-5458-4453-93B8-2224495C60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E58E1C-74F8-421A-9666-B3682C74540F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50920" y="680400"/>
            <a:ext cx="8607240" cy="12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      </a:t>
            </a:r>
            <a:r>
              <a:rPr b="0" lang="en-GB" sz="10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10           20            30           40           50            60           7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Exon 3                                      </a:t>
            </a:r>
            <a:r>
              <a:rPr b="0" lang="en-GB" sz="10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|            |             |            |            |             |            |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       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EACAM44A2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 CCA GTG </a:t>
            </a:r>
            <a:r>
              <a:rPr b="0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 CCC TCC ATC </a:t>
            </a:r>
            <a:r>
              <a:rPr b="0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G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C AGC ATA GGA CAT AAG GAC CCC AGT CAC AGA ATA </a:t>
            </a:r>
            <a:r>
              <a:rPr b="1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GA CCT..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EACAM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46A2 AG CCA GTG </a:t>
            </a:r>
            <a:r>
              <a:rPr b="0" lang="en-US" sz="10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TC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 CCC TCC ATC </a:t>
            </a:r>
            <a:r>
              <a:rPr b="0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G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C AGC ATA GGA CAT AAG GAC CCC AAT CAA GGA AAA </a:t>
            </a:r>
            <a:r>
              <a:rPr b="1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A CCC..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EACAM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47A2 AG CCA GTG </a:t>
            </a:r>
            <a:r>
              <a:rPr b="0" lang="en-US" sz="10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TC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G CCC TCC ACT </a:t>
            </a:r>
            <a:r>
              <a:rPr b="0" lang="en-US" sz="10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GG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TC GTC AAA AGA CGT AAA CAC AGC AGA TAC ATC ACA </a:t>
            </a:r>
            <a:r>
              <a:rPr b="1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GA GCC..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EACAM49A2 AT CCA GGG </a:t>
            </a:r>
            <a:r>
              <a:rPr b="0" lang="en-US" sz="10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TC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T ACC TCC ATT </a:t>
            </a:r>
            <a:r>
              <a:rPr b="0" lang="en-US" sz="10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GG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TA ACT GTA ATA CAT AAA GAC CCC AGT TAC AGA GCC </a:t>
            </a:r>
            <a:r>
              <a:rPr b="1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A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GA ACC..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EACAM48A  AG TCT GCA GCT CAC AGA AAG GAA GAC ACT ATC CAA GGA CAA </a:t>
            </a:r>
            <a:r>
              <a:rPr b="0" lang="en-US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AG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C CAT CAC CAT ACA CCC CAT TGG GAG..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9"/>
          <p:cNvSpPr/>
          <p:nvPr/>
        </p:nvSpPr>
        <p:spPr>
          <a:xfrm>
            <a:off x="253080" y="30492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7"/>
          <p:cNvSpPr/>
          <p:nvPr/>
        </p:nvSpPr>
        <p:spPr>
          <a:xfrm>
            <a:off x="251640" y="596880"/>
            <a:ext cx="152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Equus caballus, hors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9"/>
          <p:cNvSpPr/>
          <p:nvPr/>
        </p:nvSpPr>
        <p:spPr>
          <a:xfrm>
            <a:off x="253080" y="19749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feld 11"/>
          <p:cNvSpPr/>
          <p:nvPr/>
        </p:nvSpPr>
        <p:spPr>
          <a:xfrm>
            <a:off x="252720" y="2268360"/>
            <a:ext cx="144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Myotis lucifugus, bat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"/>
          <p:cNvSpPr/>
          <p:nvPr/>
        </p:nvSpPr>
        <p:spPr>
          <a:xfrm>
            <a:off x="252720" y="2622600"/>
            <a:ext cx="7419600" cy="29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Query           237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CC GCT GAA AGT GAG CCA GTT GAG CTG GAT GTA AAA 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TAG TG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CCTCCTCCTCTCCT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602650  15794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. ... ... ...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585578   2810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. ... ... ... ... ... ... .T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601230   2580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. ... .T.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T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582657   2030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C ... T.T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590007   1783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A.. ..C ... T.T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79920   2279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A.. ... ... ... ...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TG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46697    341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A.. ... ... .T. .TC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T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64992    679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T.. ..G .T. ..G ... ... ... ... .G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574784   2093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A.. ..T ... ... .TG 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. ... ... ... ... ... .....T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87580   4313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. ... .G. ... ... ... ..T ... ... .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 ... ... ......G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630864   2266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.. ... T.C ... .CA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52686   1642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TT ... ... ... ..A G..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G..TTC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252123   8634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 ..C ... ... ..G ... ... ... ... .G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T .....T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584260    275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.. ... T.C ... .CA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66298   2353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T ... .C. ... .T. .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602317  10559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A.. ..C ... ... A.G ... ... ... ... ... .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. ............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602317    848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T ... ... ... A.A GTG ... ... ... ... ..T T.. .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 ..C .A.....G..TTC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PE01309224    996 </a:t>
            </a:r>
            <a:r>
              <a:rPr b="1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.. ... .C. ... ... .GG ... ... ... ... ... ... ... 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. ...........T.....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hteck 10"/>
          <p:cNvSpPr/>
          <p:nvPr/>
        </p:nvSpPr>
        <p:spPr>
          <a:xfrm>
            <a:off x="6143760" y="2608200"/>
            <a:ext cx="228600" cy="300996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49"/>
          <p:cNvSpPr/>
          <p:nvPr/>
        </p:nvSpPr>
        <p:spPr>
          <a:xfrm>
            <a:off x="282960" y="6429240"/>
            <a:ext cx="163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hteck 15"/>
          <p:cNvSpPr/>
          <p:nvPr/>
        </p:nvSpPr>
        <p:spPr>
          <a:xfrm>
            <a:off x="5605560" y="2668680"/>
            <a:ext cx="601560" cy="142920"/>
          </a:xfrm>
          <a:prstGeom prst="rect">
            <a:avLst/>
          </a:pr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5"/>
          <p:cNvSpPr/>
          <p:nvPr/>
        </p:nvSpPr>
        <p:spPr>
          <a:xfrm>
            <a:off x="5597280" y="2432160"/>
            <a:ext cx="610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TT" sz="1000" spc="-1" strike="noStrike">
                <a:solidFill>
                  <a:srgbClr val="000000"/>
                </a:solidFill>
                <a:latin typeface="Courier New"/>
              </a:rPr>
              <a:t>GT GAG T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hteck 10"/>
          <p:cNvSpPr/>
          <p:nvPr/>
        </p:nvSpPr>
        <p:spPr>
          <a:xfrm>
            <a:off x="5818320" y="2608200"/>
            <a:ext cx="228600" cy="49860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hteck 10"/>
          <p:cNvSpPr/>
          <p:nvPr/>
        </p:nvSpPr>
        <p:spPr>
          <a:xfrm>
            <a:off x="5818320" y="3336840"/>
            <a:ext cx="228600" cy="130176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hteck 10"/>
          <p:cNvSpPr/>
          <p:nvPr/>
        </p:nvSpPr>
        <p:spPr>
          <a:xfrm>
            <a:off x="5818320" y="4857840"/>
            <a:ext cx="228600" cy="39060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hteck 10"/>
          <p:cNvSpPr/>
          <p:nvPr/>
        </p:nvSpPr>
        <p:spPr>
          <a:xfrm>
            <a:off x="5818320" y="5452920"/>
            <a:ext cx="228600" cy="16992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0T15:28:30Z</dcterms:created>
  <dc:creator>ZIMMERMANN</dc:creator>
  <dc:description/>
  <dc:language>en-US</dc:language>
  <cp:lastModifiedBy>robert.kammerer</cp:lastModifiedBy>
  <dcterms:modified xsi:type="dcterms:W3CDTF">2009-09-21T12:21:32Z</dcterms:modified>
  <cp:revision>175</cp:revision>
  <dc:subject/>
  <dc:title>Folie 1</dc:title>
</cp:coreProperties>
</file>